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24"/>
  </p:normalViewPr>
  <p:slideViewPr>
    <p:cSldViewPr snapToGrid="0" snapToObjects="1">
      <p:cViewPr varScale="1">
        <p:scale>
          <a:sx n="115" d="100"/>
          <a:sy n="115" d="100"/>
        </p:scale>
        <p:origin x="47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ameshkatam/Desktop/2019%20Proposed%20Manuscripts/2019%20Soybean-MS-Katam%20et%20al/Tables,%20Suppl.%20Tables,%20Figures%20and%20Suppl.%20Figures%20%20/Supplementary%20Figure%20XX-2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5681648882080188E-2"/>
          <c:y val="3.9832846147741546E-2"/>
          <c:w val="0.95685152562233733"/>
          <c:h val="0.750179796974197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:$B$2</c:f>
              <c:strCache>
                <c:ptCount val="2"/>
                <c:pt idx="0">
                  <c:v>PI 471938 </c:v>
                </c:pt>
                <c:pt idx="1">
                  <c:v>Contro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3:$A$53</c:f>
              <c:strCache>
                <c:ptCount val="51"/>
                <c:pt idx="0">
                  <c:v>Accession</c:v>
                </c:pt>
                <c:pt idx="2">
                  <c:v>P26413</c:v>
                </c:pt>
                <c:pt idx="3">
                  <c:v>P26413</c:v>
                </c:pt>
                <c:pt idx="4">
                  <c:v>Q39818</c:v>
                </c:pt>
                <c:pt idx="5">
                  <c:v>Q39818</c:v>
                </c:pt>
                <c:pt idx="6">
                  <c:v>P04795</c:v>
                </c:pt>
                <c:pt idx="7">
                  <c:v>P04795</c:v>
                </c:pt>
                <c:pt idx="8">
                  <c:v>B4X941</c:v>
                </c:pt>
                <c:pt idx="11">
                  <c:v>P08824</c:v>
                </c:pt>
                <c:pt idx="12">
                  <c:v>P02581</c:v>
                </c:pt>
                <c:pt idx="13">
                  <c:v>A0A762</c:v>
                </c:pt>
                <c:pt idx="16">
                  <c:v>B0M1A4</c:v>
                </c:pt>
                <c:pt idx="17">
                  <c:v>Q9ZT38</c:v>
                </c:pt>
                <c:pt idx="18">
                  <c:v>Q43758</c:v>
                </c:pt>
                <c:pt idx="19">
                  <c:v>C6SZ56</c:v>
                </c:pt>
                <c:pt idx="20">
                  <c:v>B3GV28</c:v>
                </c:pt>
                <c:pt idx="23">
                  <c:v>A8IKE5</c:v>
                </c:pt>
                <c:pt idx="24">
                  <c:v>O82560</c:v>
                </c:pt>
                <c:pt idx="25">
                  <c:v>C6ZJZ0</c:v>
                </c:pt>
                <c:pt idx="26">
                  <c:v>O23963</c:v>
                </c:pt>
                <c:pt idx="27">
                  <c:v>E5RPJ6</c:v>
                </c:pt>
                <c:pt idx="28">
                  <c:v>O81278</c:v>
                </c:pt>
                <c:pt idx="29">
                  <c:v>Q38IW8</c:v>
                </c:pt>
                <c:pt idx="30">
                  <c:v>Q93XE6</c:v>
                </c:pt>
                <c:pt idx="31">
                  <c:v>O22443</c:v>
                </c:pt>
                <c:pt idx="32">
                  <c:v>O22443</c:v>
                </c:pt>
                <c:pt idx="33">
                  <c:v>Q9XJ23</c:v>
                </c:pt>
                <c:pt idx="34">
                  <c:v>Q9SWA8</c:v>
                </c:pt>
                <c:pt idx="35">
                  <c:v>Q8GV24</c:v>
                </c:pt>
                <c:pt idx="36">
                  <c:v>O82560</c:v>
                </c:pt>
                <c:pt idx="39">
                  <c:v>D4N5G3</c:v>
                </c:pt>
                <c:pt idx="40">
                  <c:v>Q6RIB7</c:v>
                </c:pt>
                <c:pt idx="41">
                  <c:v>I1JJ05</c:v>
                </c:pt>
                <c:pt idx="42">
                  <c:v>Q2I0H4</c:v>
                </c:pt>
                <c:pt idx="43">
                  <c:v>Q39831</c:v>
                </c:pt>
                <c:pt idx="44">
                  <c:v>Q39832</c:v>
                </c:pt>
                <c:pt idx="45">
                  <c:v>Q6RUF6</c:v>
                </c:pt>
                <c:pt idx="48">
                  <c:v>Q6RIB7</c:v>
                </c:pt>
                <c:pt idx="49">
                  <c:v>P10743</c:v>
                </c:pt>
                <c:pt idx="50">
                  <c:v>Q9ZTZ2</c:v>
                </c:pt>
              </c:strCache>
            </c:strRef>
          </c:cat>
          <c:val>
            <c:numRef>
              <c:f>Sheet1!$B$3:$B$53</c:f>
              <c:numCache>
                <c:formatCode>General</c:formatCode>
                <c:ptCount val="51"/>
                <c:pt idx="0">
                  <c:v>0</c:v>
                </c:pt>
                <c:pt idx="2">
                  <c:v>10.9</c:v>
                </c:pt>
                <c:pt idx="3">
                  <c:v>2.1800000000000002</c:v>
                </c:pt>
                <c:pt idx="4">
                  <c:v>49.050000000000004</c:v>
                </c:pt>
                <c:pt idx="5">
                  <c:v>59.95</c:v>
                </c:pt>
                <c:pt idx="6">
                  <c:v>8.7200000000000006</c:v>
                </c:pt>
                <c:pt idx="7">
                  <c:v>10.9</c:v>
                </c:pt>
                <c:pt idx="8">
                  <c:v>65.400000000000006</c:v>
                </c:pt>
                <c:pt idx="11">
                  <c:v>2.1800000000000002</c:v>
                </c:pt>
                <c:pt idx="12">
                  <c:v>21.8</c:v>
                </c:pt>
                <c:pt idx="13">
                  <c:v>21.8</c:v>
                </c:pt>
                <c:pt idx="16">
                  <c:v>6.5400000000000009</c:v>
                </c:pt>
                <c:pt idx="17">
                  <c:v>2.1800000000000002</c:v>
                </c:pt>
                <c:pt idx="18">
                  <c:v>6.5400000000000009</c:v>
                </c:pt>
                <c:pt idx="19">
                  <c:v>109.00000000000001</c:v>
                </c:pt>
                <c:pt idx="20">
                  <c:v>8.7200000000000006</c:v>
                </c:pt>
                <c:pt idx="23">
                  <c:v>2.1800000000000002</c:v>
                </c:pt>
                <c:pt idx="24">
                  <c:v>6.5400000000000009</c:v>
                </c:pt>
                <c:pt idx="25">
                  <c:v>0</c:v>
                </c:pt>
                <c:pt idx="26">
                  <c:v>4.3600000000000003</c:v>
                </c:pt>
                <c:pt idx="27">
                  <c:v>8.7200000000000006</c:v>
                </c:pt>
                <c:pt idx="28">
                  <c:v>2.1800000000000002</c:v>
                </c:pt>
                <c:pt idx="29">
                  <c:v>4.3600000000000003</c:v>
                </c:pt>
                <c:pt idx="30">
                  <c:v>4.3600000000000003</c:v>
                </c:pt>
                <c:pt idx="31">
                  <c:v>26.160000000000004</c:v>
                </c:pt>
                <c:pt idx="32">
                  <c:v>4.3600000000000003</c:v>
                </c:pt>
                <c:pt idx="33">
                  <c:v>4.3600000000000003</c:v>
                </c:pt>
                <c:pt idx="34">
                  <c:v>32.700000000000003</c:v>
                </c:pt>
                <c:pt idx="35">
                  <c:v>13.080000000000002</c:v>
                </c:pt>
                <c:pt idx="36">
                  <c:v>10.9</c:v>
                </c:pt>
                <c:pt idx="39">
                  <c:v>8.7200000000000006</c:v>
                </c:pt>
                <c:pt idx="40">
                  <c:v>8.7200000000000006</c:v>
                </c:pt>
                <c:pt idx="41">
                  <c:v>32.700000000000003</c:v>
                </c:pt>
                <c:pt idx="42">
                  <c:v>17.440000000000001</c:v>
                </c:pt>
                <c:pt idx="43">
                  <c:v>6.5400000000000009</c:v>
                </c:pt>
                <c:pt idx="44">
                  <c:v>10.9</c:v>
                </c:pt>
                <c:pt idx="45">
                  <c:v>43.6</c:v>
                </c:pt>
                <c:pt idx="48">
                  <c:v>4.3600000000000003</c:v>
                </c:pt>
                <c:pt idx="49">
                  <c:v>10.9</c:v>
                </c:pt>
                <c:pt idx="50">
                  <c:v>6.54000000000000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0A-F24C-907B-BDE4005DCD86}"/>
            </c:ext>
          </c:extLst>
        </c:ser>
        <c:ser>
          <c:idx val="1"/>
          <c:order val="1"/>
          <c:tx>
            <c:strRef>
              <c:f>Sheet1!$C$1:$C$2</c:f>
              <c:strCache>
                <c:ptCount val="2"/>
                <c:pt idx="0">
                  <c:v>PI 471938 </c:v>
                </c:pt>
                <c:pt idx="1">
                  <c:v>Wate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A$3:$A$53</c:f>
              <c:strCache>
                <c:ptCount val="51"/>
                <c:pt idx="0">
                  <c:v>Accession</c:v>
                </c:pt>
                <c:pt idx="2">
                  <c:v>P26413</c:v>
                </c:pt>
                <c:pt idx="3">
                  <c:v>P26413</c:v>
                </c:pt>
                <c:pt idx="4">
                  <c:v>Q39818</c:v>
                </c:pt>
                <c:pt idx="5">
                  <c:v>Q39818</c:v>
                </c:pt>
                <c:pt idx="6">
                  <c:v>P04795</c:v>
                </c:pt>
                <c:pt idx="7">
                  <c:v>P04795</c:v>
                </c:pt>
                <c:pt idx="8">
                  <c:v>B4X941</c:v>
                </c:pt>
                <c:pt idx="11">
                  <c:v>P08824</c:v>
                </c:pt>
                <c:pt idx="12">
                  <c:v>P02581</c:v>
                </c:pt>
                <c:pt idx="13">
                  <c:v>A0A762</c:v>
                </c:pt>
                <c:pt idx="16">
                  <c:v>B0M1A4</c:v>
                </c:pt>
                <c:pt idx="17">
                  <c:v>Q9ZT38</c:v>
                </c:pt>
                <c:pt idx="18">
                  <c:v>Q43758</c:v>
                </c:pt>
                <c:pt idx="19">
                  <c:v>C6SZ56</c:v>
                </c:pt>
                <c:pt idx="20">
                  <c:v>B3GV28</c:v>
                </c:pt>
                <c:pt idx="23">
                  <c:v>A8IKE5</c:v>
                </c:pt>
                <c:pt idx="24">
                  <c:v>O82560</c:v>
                </c:pt>
                <c:pt idx="25">
                  <c:v>C6ZJZ0</c:v>
                </c:pt>
                <c:pt idx="26">
                  <c:v>O23963</c:v>
                </c:pt>
                <c:pt idx="27">
                  <c:v>E5RPJ6</c:v>
                </c:pt>
                <c:pt idx="28">
                  <c:v>O81278</c:v>
                </c:pt>
                <c:pt idx="29">
                  <c:v>Q38IW8</c:v>
                </c:pt>
                <c:pt idx="30">
                  <c:v>Q93XE6</c:v>
                </c:pt>
                <c:pt idx="31">
                  <c:v>O22443</c:v>
                </c:pt>
                <c:pt idx="32">
                  <c:v>O22443</c:v>
                </c:pt>
                <c:pt idx="33">
                  <c:v>Q9XJ23</c:v>
                </c:pt>
                <c:pt idx="34">
                  <c:v>Q9SWA8</c:v>
                </c:pt>
                <c:pt idx="35">
                  <c:v>Q8GV24</c:v>
                </c:pt>
                <c:pt idx="36">
                  <c:v>O82560</c:v>
                </c:pt>
                <c:pt idx="39">
                  <c:v>D4N5G3</c:v>
                </c:pt>
                <c:pt idx="40">
                  <c:v>Q6RIB7</c:v>
                </c:pt>
                <c:pt idx="41">
                  <c:v>I1JJ05</c:v>
                </c:pt>
                <c:pt idx="42">
                  <c:v>Q2I0H4</c:v>
                </c:pt>
                <c:pt idx="43">
                  <c:v>Q39831</c:v>
                </c:pt>
                <c:pt idx="44">
                  <c:v>Q39832</c:v>
                </c:pt>
                <c:pt idx="45">
                  <c:v>Q6RUF6</c:v>
                </c:pt>
                <c:pt idx="48">
                  <c:v>Q6RIB7</c:v>
                </c:pt>
                <c:pt idx="49">
                  <c:v>P10743</c:v>
                </c:pt>
                <c:pt idx="50">
                  <c:v>Q9ZTZ2</c:v>
                </c:pt>
              </c:strCache>
            </c:strRef>
          </c:cat>
          <c:val>
            <c:numRef>
              <c:f>Sheet1!$C$3:$C$53</c:f>
              <c:numCache>
                <c:formatCode>General</c:formatCode>
                <c:ptCount val="51"/>
                <c:pt idx="0">
                  <c:v>0</c:v>
                </c:pt>
                <c:pt idx="2">
                  <c:v>8.7200000000000006</c:v>
                </c:pt>
                <c:pt idx="3">
                  <c:v>2.1800000000000002</c:v>
                </c:pt>
                <c:pt idx="4">
                  <c:v>54.500000000000007</c:v>
                </c:pt>
                <c:pt idx="5">
                  <c:v>54.500000000000007</c:v>
                </c:pt>
                <c:pt idx="6">
                  <c:v>6.5400000000000009</c:v>
                </c:pt>
                <c:pt idx="7">
                  <c:v>0</c:v>
                </c:pt>
                <c:pt idx="8">
                  <c:v>13.080000000000002</c:v>
                </c:pt>
                <c:pt idx="11">
                  <c:v>0</c:v>
                </c:pt>
                <c:pt idx="12">
                  <c:v>10.9</c:v>
                </c:pt>
                <c:pt idx="13">
                  <c:v>8.7200000000000006</c:v>
                </c:pt>
                <c:pt idx="16">
                  <c:v>2.1800000000000002</c:v>
                </c:pt>
                <c:pt idx="17">
                  <c:v>0</c:v>
                </c:pt>
                <c:pt idx="18">
                  <c:v>2.1800000000000002</c:v>
                </c:pt>
                <c:pt idx="19">
                  <c:v>109.00000000000001</c:v>
                </c:pt>
                <c:pt idx="20">
                  <c:v>4.3600000000000003</c:v>
                </c:pt>
                <c:pt idx="23">
                  <c:v>6.5400000000000009</c:v>
                </c:pt>
                <c:pt idx="24">
                  <c:v>2.1800000000000002</c:v>
                </c:pt>
                <c:pt idx="25">
                  <c:v>0</c:v>
                </c:pt>
                <c:pt idx="26">
                  <c:v>2.1800000000000002</c:v>
                </c:pt>
                <c:pt idx="27">
                  <c:v>2.1800000000000002</c:v>
                </c:pt>
                <c:pt idx="28">
                  <c:v>2.1800000000000002</c:v>
                </c:pt>
                <c:pt idx="29">
                  <c:v>2.1800000000000002</c:v>
                </c:pt>
                <c:pt idx="30">
                  <c:v>2.1800000000000002</c:v>
                </c:pt>
                <c:pt idx="31">
                  <c:v>13.080000000000002</c:v>
                </c:pt>
                <c:pt idx="32">
                  <c:v>2.1800000000000002</c:v>
                </c:pt>
                <c:pt idx="33">
                  <c:v>8.7200000000000006</c:v>
                </c:pt>
                <c:pt idx="34">
                  <c:v>10.9</c:v>
                </c:pt>
                <c:pt idx="35">
                  <c:v>8.7200000000000006</c:v>
                </c:pt>
                <c:pt idx="36">
                  <c:v>2.1800000000000002</c:v>
                </c:pt>
                <c:pt idx="39">
                  <c:v>6.5400000000000009</c:v>
                </c:pt>
                <c:pt idx="40">
                  <c:v>8.7200000000000006</c:v>
                </c:pt>
                <c:pt idx="41">
                  <c:v>43.6</c:v>
                </c:pt>
                <c:pt idx="42">
                  <c:v>39.24</c:v>
                </c:pt>
                <c:pt idx="43">
                  <c:v>0</c:v>
                </c:pt>
                <c:pt idx="44">
                  <c:v>0</c:v>
                </c:pt>
                <c:pt idx="45">
                  <c:v>32.700000000000003</c:v>
                </c:pt>
                <c:pt idx="48">
                  <c:v>10.9</c:v>
                </c:pt>
                <c:pt idx="49">
                  <c:v>6.5400000000000009</c:v>
                </c:pt>
                <c:pt idx="50">
                  <c:v>2.18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E0A-F24C-907B-BDE4005DCD86}"/>
            </c:ext>
          </c:extLst>
        </c:ser>
        <c:ser>
          <c:idx val="2"/>
          <c:order val="2"/>
          <c:tx>
            <c:strRef>
              <c:f>Sheet1!$D$1:$D$2</c:f>
              <c:strCache>
                <c:ptCount val="2"/>
                <c:pt idx="0">
                  <c:v>PI 471938 </c:v>
                </c:pt>
                <c:pt idx="1">
                  <c:v>Hea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A$3:$A$53</c:f>
              <c:strCache>
                <c:ptCount val="51"/>
                <c:pt idx="0">
                  <c:v>Accession</c:v>
                </c:pt>
                <c:pt idx="2">
                  <c:v>P26413</c:v>
                </c:pt>
                <c:pt idx="3">
                  <c:v>P26413</c:v>
                </c:pt>
                <c:pt idx="4">
                  <c:v>Q39818</c:v>
                </c:pt>
                <c:pt idx="5">
                  <c:v>Q39818</c:v>
                </c:pt>
                <c:pt idx="6">
                  <c:v>P04795</c:v>
                </c:pt>
                <c:pt idx="7">
                  <c:v>P04795</c:v>
                </c:pt>
                <c:pt idx="8">
                  <c:v>B4X941</c:v>
                </c:pt>
                <c:pt idx="11">
                  <c:v>P08824</c:v>
                </c:pt>
                <c:pt idx="12">
                  <c:v>P02581</c:v>
                </c:pt>
                <c:pt idx="13">
                  <c:v>A0A762</c:v>
                </c:pt>
                <c:pt idx="16">
                  <c:v>B0M1A4</c:v>
                </c:pt>
                <c:pt idx="17">
                  <c:v>Q9ZT38</c:v>
                </c:pt>
                <c:pt idx="18">
                  <c:v>Q43758</c:v>
                </c:pt>
                <c:pt idx="19">
                  <c:v>C6SZ56</c:v>
                </c:pt>
                <c:pt idx="20">
                  <c:v>B3GV28</c:v>
                </c:pt>
                <c:pt idx="23">
                  <c:v>A8IKE5</c:v>
                </c:pt>
                <c:pt idx="24">
                  <c:v>O82560</c:v>
                </c:pt>
                <c:pt idx="25">
                  <c:v>C6ZJZ0</c:v>
                </c:pt>
                <c:pt idx="26">
                  <c:v>O23963</c:v>
                </c:pt>
                <c:pt idx="27">
                  <c:v>E5RPJ6</c:v>
                </c:pt>
                <c:pt idx="28">
                  <c:v>O81278</c:v>
                </c:pt>
                <c:pt idx="29">
                  <c:v>Q38IW8</c:v>
                </c:pt>
                <c:pt idx="30">
                  <c:v>Q93XE6</c:v>
                </c:pt>
                <c:pt idx="31">
                  <c:v>O22443</c:v>
                </c:pt>
                <c:pt idx="32">
                  <c:v>O22443</c:v>
                </c:pt>
                <c:pt idx="33">
                  <c:v>Q9XJ23</c:v>
                </c:pt>
                <c:pt idx="34">
                  <c:v>Q9SWA8</c:v>
                </c:pt>
                <c:pt idx="35">
                  <c:v>Q8GV24</c:v>
                </c:pt>
                <c:pt idx="36">
                  <c:v>O82560</c:v>
                </c:pt>
                <c:pt idx="39">
                  <c:v>D4N5G3</c:v>
                </c:pt>
                <c:pt idx="40">
                  <c:v>Q6RIB7</c:v>
                </c:pt>
                <c:pt idx="41">
                  <c:v>I1JJ05</c:v>
                </c:pt>
                <c:pt idx="42">
                  <c:v>Q2I0H4</c:v>
                </c:pt>
                <c:pt idx="43">
                  <c:v>Q39831</c:v>
                </c:pt>
                <c:pt idx="44">
                  <c:v>Q39832</c:v>
                </c:pt>
                <c:pt idx="45">
                  <c:v>Q6RUF6</c:v>
                </c:pt>
                <c:pt idx="48">
                  <c:v>Q6RIB7</c:v>
                </c:pt>
                <c:pt idx="49">
                  <c:v>P10743</c:v>
                </c:pt>
                <c:pt idx="50">
                  <c:v>Q9ZTZ2</c:v>
                </c:pt>
              </c:strCache>
            </c:strRef>
          </c:cat>
          <c:val>
            <c:numRef>
              <c:f>Sheet1!$D$3:$D$53</c:f>
              <c:numCache>
                <c:formatCode>General</c:formatCode>
                <c:ptCount val="51"/>
                <c:pt idx="0">
                  <c:v>0</c:v>
                </c:pt>
                <c:pt idx="2">
                  <c:v>15.26</c:v>
                </c:pt>
                <c:pt idx="3">
                  <c:v>2.1800000000000002</c:v>
                </c:pt>
                <c:pt idx="4">
                  <c:v>65.400000000000006</c:v>
                </c:pt>
                <c:pt idx="5">
                  <c:v>109.00000000000001</c:v>
                </c:pt>
                <c:pt idx="6">
                  <c:v>10.9</c:v>
                </c:pt>
                <c:pt idx="7">
                  <c:v>13.080000000000002</c:v>
                </c:pt>
                <c:pt idx="8">
                  <c:v>65.400000000000006</c:v>
                </c:pt>
                <c:pt idx="11">
                  <c:v>2.1800000000000002</c:v>
                </c:pt>
                <c:pt idx="12">
                  <c:v>15.260000000000002</c:v>
                </c:pt>
                <c:pt idx="13">
                  <c:v>26.160000000000004</c:v>
                </c:pt>
                <c:pt idx="16">
                  <c:v>6.5400000000000009</c:v>
                </c:pt>
                <c:pt idx="17">
                  <c:v>2.1800000000000002</c:v>
                </c:pt>
                <c:pt idx="18">
                  <c:v>6.5400000000000009</c:v>
                </c:pt>
                <c:pt idx="19">
                  <c:v>109.00000000000001</c:v>
                </c:pt>
                <c:pt idx="20">
                  <c:v>4.3600000000000003</c:v>
                </c:pt>
                <c:pt idx="23">
                  <c:v>6.5400000000000009</c:v>
                </c:pt>
                <c:pt idx="24">
                  <c:v>2.1800000000000002</c:v>
                </c:pt>
                <c:pt idx="25">
                  <c:v>0</c:v>
                </c:pt>
                <c:pt idx="26">
                  <c:v>2.1800000000000002</c:v>
                </c:pt>
                <c:pt idx="27">
                  <c:v>6.5400000000000009</c:v>
                </c:pt>
                <c:pt idx="28">
                  <c:v>0</c:v>
                </c:pt>
                <c:pt idx="29">
                  <c:v>4.3600000000000003</c:v>
                </c:pt>
                <c:pt idx="30">
                  <c:v>2.1800000000000002</c:v>
                </c:pt>
                <c:pt idx="31">
                  <c:v>4.3600000000000003</c:v>
                </c:pt>
                <c:pt idx="32">
                  <c:v>2.1800000000000002</c:v>
                </c:pt>
                <c:pt idx="33">
                  <c:v>6.5400000000000009</c:v>
                </c:pt>
                <c:pt idx="34">
                  <c:v>43.6</c:v>
                </c:pt>
                <c:pt idx="35">
                  <c:v>13.080000000000002</c:v>
                </c:pt>
                <c:pt idx="36">
                  <c:v>10.9</c:v>
                </c:pt>
                <c:pt idx="39">
                  <c:v>6.5400000000000009</c:v>
                </c:pt>
                <c:pt idx="40">
                  <c:v>8.7200000000000006</c:v>
                </c:pt>
                <c:pt idx="41">
                  <c:v>21.8</c:v>
                </c:pt>
                <c:pt idx="42">
                  <c:v>39.24</c:v>
                </c:pt>
                <c:pt idx="43">
                  <c:v>8.7200000000000006</c:v>
                </c:pt>
                <c:pt idx="44">
                  <c:v>10.9</c:v>
                </c:pt>
                <c:pt idx="45">
                  <c:v>32.700000000000003</c:v>
                </c:pt>
                <c:pt idx="48">
                  <c:v>10.9</c:v>
                </c:pt>
                <c:pt idx="49">
                  <c:v>13.080000000000002</c:v>
                </c:pt>
                <c:pt idx="50">
                  <c:v>6.54000000000000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E0A-F24C-907B-BDE4005DCD86}"/>
            </c:ext>
          </c:extLst>
        </c:ser>
        <c:ser>
          <c:idx val="3"/>
          <c:order val="3"/>
          <c:tx>
            <c:strRef>
              <c:f>Sheet1!$E$1:$E$2</c:f>
              <c:strCache>
                <c:ptCount val="2"/>
                <c:pt idx="0">
                  <c:v>PI 471938 </c:v>
                </c:pt>
                <c:pt idx="1">
                  <c:v>Bo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A$3:$A$53</c:f>
              <c:strCache>
                <c:ptCount val="51"/>
                <c:pt idx="0">
                  <c:v>Accession</c:v>
                </c:pt>
                <c:pt idx="2">
                  <c:v>P26413</c:v>
                </c:pt>
                <c:pt idx="3">
                  <c:v>P26413</c:v>
                </c:pt>
                <c:pt idx="4">
                  <c:v>Q39818</c:v>
                </c:pt>
                <c:pt idx="5">
                  <c:v>Q39818</c:v>
                </c:pt>
                <c:pt idx="6">
                  <c:v>P04795</c:v>
                </c:pt>
                <c:pt idx="7">
                  <c:v>P04795</c:v>
                </c:pt>
                <c:pt idx="8">
                  <c:v>B4X941</c:v>
                </c:pt>
                <c:pt idx="11">
                  <c:v>P08824</c:v>
                </c:pt>
                <c:pt idx="12">
                  <c:v>P02581</c:v>
                </c:pt>
                <c:pt idx="13">
                  <c:v>A0A762</c:v>
                </c:pt>
                <c:pt idx="16">
                  <c:v>B0M1A4</c:v>
                </c:pt>
                <c:pt idx="17">
                  <c:v>Q9ZT38</c:v>
                </c:pt>
                <c:pt idx="18">
                  <c:v>Q43758</c:v>
                </c:pt>
                <c:pt idx="19">
                  <c:v>C6SZ56</c:v>
                </c:pt>
                <c:pt idx="20">
                  <c:v>B3GV28</c:v>
                </c:pt>
                <c:pt idx="23">
                  <c:v>A8IKE5</c:v>
                </c:pt>
                <c:pt idx="24">
                  <c:v>O82560</c:v>
                </c:pt>
                <c:pt idx="25">
                  <c:v>C6ZJZ0</c:v>
                </c:pt>
                <c:pt idx="26">
                  <c:v>O23963</c:v>
                </c:pt>
                <c:pt idx="27">
                  <c:v>E5RPJ6</c:v>
                </c:pt>
                <c:pt idx="28">
                  <c:v>O81278</c:v>
                </c:pt>
                <c:pt idx="29">
                  <c:v>Q38IW8</c:v>
                </c:pt>
                <c:pt idx="30">
                  <c:v>Q93XE6</c:v>
                </c:pt>
                <c:pt idx="31">
                  <c:v>O22443</c:v>
                </c:pt>
                <c:pt idx="32">
                  <c:v>O22443</c:v>
                </c:pt>
                <c:pt idx="33">
                  <c:v>Q9XJ23</c:v>
                </c:pt>
                <c:pt idx="34">
                  <c:v>Q9SWA8</c:v>
                </c:pt>
                <c:pt idx="35">
                  <c:v>Q8GV24</c:v>
                </c:pt>
                <c:pt idx="36">
                  <c:v>O82560</c:v>
                </c:pt>
                <c:pt idx="39">
                  <c:v>D4N5G3</c:v>
                </c:pt>
                <c:pt idx="40">
                  <c:v>Q6RIB7</c:v>
                </c:pt>
                <c:pt idx="41">
                  <c:v>I1JJ05</c:v>
                </c:pt>
                <c:pt idx="42">
                  <c:v>Q2I0H4</c:v>
                </c:pt>
                <c:pt idx="43">
                  <c:v>Q39831</c:v>
                </c:pt>
                <c:pt idx="44">
                  <c:v>Q39832</c:v>
                </c:pt>
                <c:pt idx="45">
                  <c:v>Q6RUF6</c:v>
                </c:pt>
                <c:pt idx="48">
                  <c:v>Q6RIB7</c:v>
                </c:pt>
                <c:pt idx="49">
                  <c:v>P10743</c:v>
                </c:pt>
                <c:pt idx="50">
                  <c:v>Q9ZTZ2</c:v>
                </c:pt>
              </c:strCache>
            </c:strRef>
          </c:cat>
          <c:val>
            <c:numRef>
              <c:f>Sheet1!$E$3:$E$53</c:f>
              <c:numCache>
                <c:formatCode>General</c:formatCode>
                <c:ptCount val="51"/>
                <c:pt idx="0">
                  <c:v>0</c:v>
                </c:pt>
                <c:pt idx="2">
                  <c:v>13.08</c:v>
                </c:pt>
                <c:pt idx="3">
                  <c:v>6.5400000000000009</c:v>
                </c:pt>
                <c:pt idx="4">
                  <c:v>65.400000000000006</c:v>
                </c:pt>
                <c:pt idx="5">
                  <c:v>98.100000000000009</c:v>
                </c:pt>
                <c:pt idx="6">
                  <c:v>21.8</c:v>
                </c:pt>
                <c:pt idx="7">
                  <c:v>2.1800000000000002</c:v>
                </c:pt>
                <c:pt idx="8">
                  <c:v>21.8</c:v>
                </c:pt>
                <c:pt idx="11">
                  <c:v>0</c:v>
                </c:pt>
                <c:pt idx="12">
                  <c:v>21.8</c:v>
                </c:pt>
                <c:pt idx="13">
                  <c:v>2.1800000000000002</c:v>
                </c:pt>
                <c:pt idx="16">
                  <c:v>6.5400000000000009</c:v>
                </c:pt>
                <c:pt idx="17">
                  <c:v>2.1800000000000002</c:v>
                </c:pt>
                <c:pt idx="18">
                  <c:v>2.1800000000000002</c:v>
                </c:pt>
                <c:pt idx="19">
                  <c:v>65.400000000000006</c:v>
                </c:pt>
                <c:pt idx="20">
                  <c:v>2.1800000000000002</c:v>
                </c:pt>
                <c:pt idx="23">
                  <c:v>2.1800000000000002</c:v>
                </c:pt>
                <c:pt idx="24">
                  <c:v>2.1800000000000002</c:v>
                </c:pt>
                <c:pt idx="25">
                  <c:v>2.1800000000000002</c:v>
                </c:pt>
                <c:pt idx="26">
                  <c:v>2.1800000000000002</c:v>
                </c:pt>
                <c:pt idx="27">
                  <c:v>2.1800000000000002</c:v>
                </c:pt>
                <c:pt idx="28">
                  <c:v>4.3600000000000003</c:v>
                </c:pt>
                <c:pt idx="29">
                  <c:v>2.1800000000000002</c:v>
                </c:pt>
                <c:pt idx="30">
                  <c:v>2.1800000000000002</c:v>
                </c:pt>
                <c:pt idx="31">
                  <c:v>15.260000000000002</c:v>
                </c:pt>
                <c:pt idx="32">
                  <c:v>4.3600000000000003</c:v>
                </c:pt>
                <c:pt idx="33">
                  <c:v>4.3600000000000003</c:v>
                </c:pt>
                <c:pt idx="34">
                  <c:v>17.440000000000001</c:v>
                </c:pt>
                <c:pt idx="35">
                  <c:v>8.7200000000000006</c:v>
                </c:pt>
                <c:pt idx="36">
                  <c:v>10.9</c:v>
                </c:pt>
                <c:pt idx="39">
                  <c:v>21.8</c:v>
                </c:pt>
                <c:pt idx="40">
                  <c:v>43.6</c:v>
                </c:pt>
                <c:pt idx="41">
                  <c:v>21.8</c:v>
                </c:pt>
                <c:pt idx="42">
                  <c:v>17.440000000000001</c:v>
                </c:pt>
                <c:pt idx="43">
                  <c:v>17.440000000000001</c:v>
                </c:pt>
                <c:pt idx="44">
                  <c:v>4.3600000000000003</c:v>
                </c:pt>
                <c:pt idx="45">
                  <c:v>21.8</c:v>
                </c:pt>
                <c:pt idx="48">
                  <c:v>65.400000000000006</c:v>
                </c:pt>
                <c:pt idx="49">
                  <c:v>2.1800000000000002</c:v>
                </c:pt>
                <c:pt idx="50">
                  <c:v>10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E0A-F24C-907B-BDE4005DCD86}"/>
            </c:ext>
          </c:extLst>
        </c:ser>
        <c:ser>
          <c:idx val="4"/>
          <c:order val="4"/>
          <c:tx>
            <c:strRef>
              <c:f>Sheet1!$F$1:$F$2</c:f>
              <c:strCache>
                <c:ptCount val="2"/>
                <c:pt idx="0">
                  <c:v>PI 471938 </c:v>
                </c:pt>
                <c:pt idx="1">
                  <c:v>Both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1!$A$3:$A$53</c:f>
              <c:strCache>
                <c:ptCount val="51"/>
                <c:pt idx="0">
                  <c:v>Accession</c:v>
                </c:pt>
                <c:pt idx="2">
                  <c:v>P26413</c:v>
                </c:pt>
                <c:pt idx="3">
                  <c:v>P26413</c:v>
                </c:pt>
                <c:pt idx="4">
                  <c:v>Q39818</c:v>
                </c:pt>
                <c:pt idx="5">
                  <c:v>Q39818</c:v>
                </c:pt>
                <c:pt idx="6">
                  <c:v>P04795</c:v>
                </c:pt>
                <c:pt idx="7">
                  <c:v>P04795</c:v>
                </c:pt>
                <c:pt idx="8">
                  <c:v>B4X941</c:v>
                </c:pt>
                <c:pt idx="11">
                  <c:v>P08824</c:v>
                </c:pt>
                <c:pt idx="12">
                  <c:v>P02581</c:v>
                </c:pt>
                <c:pt idx="13">
                  <c:v>A0A762</c:v>
                </c:pt>
                <c:pt idx="16">
                  <c:v>B0M1A4</c:v>
                </c:pt>
                <c:pt idx="17">
                  <c:v>Q9ZT38</c:v>
                </c:pt>
                <c:pt idx="18">
                  <c:v>Q43758</c:v>
                </c:pt>
                <c:pt idx="19">
                  <c:v>C6SZ56</c:v>
                </c:pt>
                <c:pt idx="20">
                  <c:v>B3GV28</c:v>
                </c:pt>
                <c:pt idx="23">
                  <c:v>A8IKE5</c:v>
                </c:pt>
                <c:pt idx="24">
                  <c:v>O82560</c:v>
                </c:pt>
                <c:pt idx="25">
                  <c:v>C6ZJZ0</c:v>
                </c:pt>
                <c:pt idx="26">
                  <c:v>O23963</c:v>
                </c:pt>
                <c:pt idx="27">
                  <c:v>E5RPJ6</c:v>
                </c:pt>
                <c:pt idx="28">
                  <c:v>O81278</c:v>
                </c:pt>
                <c:pt idx="29">
                  <c:v>Q38IW8</c:v>
                </c:pt>
                <c:pt idx="30">
                  <c:v>Q93XE6</c:v>
                </c:pt>
                <c:pt idx="31">
                  <c:v>O22443</c:v>
                </c:pt>
                <c:pt idx="32">
                  <c:v>O22443</c:v>
                </c:pt>
                <c:pt idx="33">
                  <c:v>Q9XJ23</c:v>
                </c:pt>
                <c:pt idx="34">
                  <c:v>Q9SWA8</c:v>
                </c:pt>
                <c:pt idx="35">
                  <c:v>Q8GV24</c:v>
                </c:pt>
                <c:pt idx="36">
                  <c:v>O82560</c:v>
                </c:pt>
                <c:pt idx="39">
                  <c:v>D4N5G3</c:v>
                </c:pt>
                <c:pt idx="40">
                  <c:v>Q6RIB7</c:v>
                </c:pt>
                <c:pt idx="41">
                  <c:v>I1JJ05</c:v>
                </c:pt>
                <c:pt idx="42">
                  <c:v>Q2I0H4</c:v>
                </c:pt>
                <c:pt idx="43">
                  <c:v>Q39831</c:v>
                </c:pt>
                <c:pt idx="44">
                  <c:v>Q39832</c:v>
                </c:pt>
                <c:pt idx="45">
                  <c:v>Q6RUF6</c:v>
                </c:pt>
                <c:pt idx="48">
                  <c:v>Q6RIB7</c:v>
                </c:pt>
                <c:pt idx="49">
                  <c:v>P10743</c:v>
                </c:pt>
                <c:pt idx="50">
                  <c:v>Q9ZTZ2</c:v>
                </c:pt>
              </c:strCache>
            </c:strRef>
          </c:cat>
          <c:val>
            <c:numRef>
              <c:f>Sheet1!$F$3:$F$53</c:f>
              <c:numCache>
                <c:formatCode>General</c:formatCode>
                <c:ptCount val="51"/>
                <c:pt idx="0">
                  <c:v>0</c:v>
                </c:pt>
                <c:pt idx="2">
                  <c:v>1</c:v>
                </c:pt>
                <c:pt idx="3">
                  <c:v>3</c:v>
                </c:pt>
                <c:pt idx="4">
                  <c:v>27</c:v>
                </c:pt>
                <c:pt idx="5">
                  <c:v>28</c:v>
                </c:pt>
                <c:pt idx="6">
                  <c:v>31</c:v>
                </c:pt>
                <c:pt idx="7">
                  <c:v>32</c:v>
                </c:pt>
                <c:pt idx="8">
                  <c:v>34</c:v>
                </c:pt>
                <c:pt idx="11">
                  <c:v>2</c:v>
                </c:pt>
                <c:pt idx="12">
                  <c:v>6</c:v>
                </c:pt>
                <c:pt idx="13">
                  <c:v>11</c:v>
                </c:pt>
                <c:pt idx="16">
                  <c:v>5</c:v>
                </c:pt>
                <c:pt idx="17">
                  <c:v>14</c:v>
                </c:pt>
                <c:pt idx="18">
                  <c:v>19</c:v>
                </c:pt>
                <c:pt idx="19">
                  <c:v>26</c:v>
                </c:pt>
                <c:pt idx="20">
                  <c:v>29</c:v>
                </c:pt>
                <c:pt idx="23">
                  <c:v>4</c:v>
                </c:pt>
                <c:pt idx="24">
                  <c:v>7</c:v>
                </c:pt>
                <c:pt idx="25">
                  <c:v>12</c:v>
                </c:pt>
                <c:pt idx="26">
                  <c:v>13</c:v>
                </c:pt>
                <c:pt idx="27">
                  <c:v>15</c:v>
                </c:pt>
                <c:pt idx="28">
                  <c:v>18</c:v>
                </c:pt>
                <c:pt idx="29">
                  <c:v>20</c:v>
                </c:pt>
                <c:pt idx="30">
                  <c:v>21</c:v>
                </c:pt>
                <c:pt idx="31">
                  <c:v>22</c:v>
                </c:pt>
                <c:pt idx="32">
                  <c:v>23</c:v>
                </c:pt>
                <c:pt idx="33">
                  <c:v>24</c:v>
                </c:pt>
                <c:pt idx="34">
                  <c:v>33</c:v>
                </c:pt>
                <c:pt idx="35">
                  <c:v>37</c:v>
                </c:pt>
                <c:pt idx="36">
                  <c:v>39</c:v>
                </c:pt>
                <c:pt idx="39">
                  <c:v>8</c:v>
                </c:pt>
                <c:pt idx="40">
                  <c:v>9</c:v>
                </c:pt>
                <c:pt idx="41">
                  <c:v>16</c:v>
                </c:pt>
                <c:pt idx="42">
                  <c:v>17</c:v>
                </c:pt>
                <c:pt idx="43">
                  <c:v>25</c:v>
                </c:pt>
                <c:pt idx="44">
                  <c:v>30</c:v>
                </c:pt>
                <c:pt idx="45">
                  <c:v>38</c:v>
                </c:pt>
                <c:pt idx="48">
                  <c:v>10</c:v>
                </c:pt>
                <c:pt idx="49">
                  <c:v>35</c:v>
                </c:pt>
                <c:pt idx="50">
                  <c:v>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E0A-F24C-907B-BDE4005DCD86}"/>
            </c:ext>
          </c:extLst>
        </c:ser>
        <c:ser>
          <c:idx val="5"/>
          <c:order val="5"/>
          <c:tx>
            <c:strRef>
              <c:f>Sheet1!$G$1:$G$2</c:f>
              <c:strCache>
                <c:ptCount val="2"/>
                <c:pt idx="0">
                  <c:v>R95–1705 </c:v>
                </c:pt>
                <c:pt idx="1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1!$A$3:$A$53</c:f>
              <c:strCache>
                <c:ptCount val="51"/>
                <c:pt idx="0">
                  <c:v>Accession</c:v>
                </c:pt>
                <c:pt idx="2">
                  <c:v>P26413</c:v>
                </c:pt>
                <c:pt idx="3">
                  <c:v>P26413</c:v>
                </c:pt>
                <c:pt idx="4">
                  <c:v>Q39818</c:v>
                </c:pt>
                <c:pt idx="5">
                  <c:v>Q39818</c:v>
                </c:pt>
                <c:pt idx="6">
                  <c:v>P04795</c:v>
                </c:pt>
                <c:pt idx="7">
                  <c:v>P04795</c:v>
                </c:pt>
                <c:pt idx="8">
                  <c:v>B4X941</c:v>
                </c:pt>
                <c:pt idx="11">
                  <c:v>P08824</c:v>
                </c:pt>
                <c:pt idx="12">
                  <c:v>P02581</c:v>
                </c:pt>
                <c:pt idx="13">
                  <c:v>A0A762</c:v>
                </c:pt>
                <c:pt idx="16">
                  <c:v>B0M1A4</c:v>
                </c:pt>
                <c:pt idx="17">
                  <c:v>Q9ZT38</c:v>
                </c:pt>
                <c:pt idx="18">
                  <c:v>Q43758</c:v>
                </c:pt>
                <c:pt idx="19">
                  <c:v>C6SZ56</c:v>
                </c:pt>
                <c:pt idx="20">
                  <c:v>B3GV28</c:v>
                </c:pt>
                <c:pt idx="23">
                  <c:v>A8IKE5</c:v>
                </c:pt>
                <c:pt idx="24">
                  <c:v>O82560</c:v>
                </c:pt>
                <c:pt idx="25">
                  <c:v>C6ZJZ0</c:v>
                </c:pt>
                <c:pt idx="26">
                  <c:v>O23963</c:v>
                </c:pt>
                <c:pt idx="27">
                  <c:v>E5RPJ6</c:v>
                </c:pt>
                <c:pt idx="28">
                  <c:v>O81278</c:v>
                </c:pt>
                <c:pt idx="29">
                  <c:v>Q38IW8</c:v>
                </c:pt>
                <c:pt idx="30">
                  <c:v>Q93XE6</c:v>
                </c:pt>
                <c:pt idx="31">
                  <c:v>O22443</c:v>
                </c:pt>
                <c:pt idx="32">
                  <c:v>O22443</c:v>
                </c:pt>
                <c:pt idx="33">
                  <c:v>Q9XJ23</c:v>
                </c:pt>
                <c:pt idx="34">
                  <c:v>Q9SWA8</c:v>
                </c:pt>
                <c:pt idx="35">
                  <c:v>Q8GV24</c:v>
                </c:pt>
                <c:pt idx="36">
                  <c:v>O82560</c:v>
                </c:pt>
                <c:pt idx="39">
                  <c:v>D4N5G3</c:v>
                </c:pt>
                <c:pt idx="40">
                  <c:v>Q6RIB7</c:v>
                </c:pt>
                <c:pt idx="41">
                  <c:v>I1JJ05</c:v>
                </c:pt>
                <c:pt idx="42">
                  <c:v>Q2I0H4</c:v>
                </c:pt>
                <c:pt idx="43">
                  <c:v>Q39831</c:v>
                </c:pt>
                <c:pt idx="44">
                  <c:v>Q39832</c:v>
                </c:pt>
                <c:pt idx="45">
                  <c:v>Q6RUF6</c:v>
                </c:pt>
                <c:pt idx="48">
                  <c:v>Q6RIB7</c:v>
                </c:pt>
                <c:pt idx="49">
                  <c:v>P10743</c:v>
                </c:pt>
                <c:pt idx="50">
                  <c:v>Q9ZTZ2</c:v>
                </c:pt>
              </c:strCache>
            </c:strRef>
          </c:cat>
          <c:val>
            <c:numRef>
              <c:f>Sheet1!$G$3:$G$53</c:f>
              <c:numCache>
                <c:formatCode>General</c:formatCode>
                <c:ptCount val="51"/>
                <c:pt idx="0">
                  <c:v>0</c:v>
                </c:pt>
                <c:pt idx="2">
                  <c:v>10.9</c:v>
                </c:pt>
                <c:pt idx="3">
                  <c:v>2.1800000000000002</c:v>
                </c:pt>
                <c:pt idx="4">
                  <c:v>32.700000000000003</c:v>
                </c:pt>
                <c:pt idx="5">
                  <c:v>109.00000000000001</c:v>
                </c:pt>
                <c:pt idx="6">
                  <c:v>8.7200000000000006</c:v>
                </c:pt>
                <c:pt idx="7">
                  <c:v>2.1800000000000002</c:v>
                </c:pt>
                <c:pt idx="8">
                  <c:v>43.6</c:v>
                </c:pt>
                <c:pt idx="11">
                  <c:v>2.1800000000000002</c:v>
                </c:pt>
                <c:pt idx="12">
                  <c:v>17.440000000000001</c:v>
                </c:pt>
                <c:pt idx="13">
                  <c:v>4.3600000000000003</c:v>
                </c:pt>
                <c:pt idx="16">
                  <c:v>6.5400000000000009</c:v>
                </c:pt>
                <c:pt idx="17">
                  <c:v>2.1800000000000002</c:v>
                </c:pt>
                <c:pt idx="18">
                  <c:v>6.5400000000000009</c:v>
                </c:pt>
                <c:pt idx="19">
                  <c:v>109.00000000000001</c:v>
                </c:pt>
                <c:pt idx="20">
                  <c:v>4.3600000000000003</c:v>
                </c:pt>
                <c:pt idx="23">
                  <c:v>2.1800000000000002</c:v>
                </c:pt>
                <c:pt idx="24">
                  <c:v>0</c:v>
                </c:pt>
                <c:pt idx="25">
                  <c:v>0</c:v>
                </c:pt>
                <c:pt idx="26">
                  <c:v>8.7200000000000006</c:v>
                </c:pt>
                <c:pt idx="27">
                  <c:v>4.3600000000000003</c:v>
                </c:pt>
                <c:pt idx="28">
                  <c:v>2.1800000000000002</c:v>
                </c:pt>
                <c:pt idx="29">
                  <c:v>2.1800000000000002</c:v>
                </c:pt>
                <c:pt idx="30">
                  <c:v>2.1800000000000002</c:v>
                </c:pt>
                <c:pt idx="31">
                  <c:v>13.080000000000002</c:v>
                </c:pt>
                <c:pt idx="32">
                  <c:v>2.1800000000000002</c:v>
                </c:pt>
                <c:pt idx="33">
                  <c:v>2.1800000000000002</c:v>
                </c:pt>
                <c:pt idx="34">
                  <c:v>10.9</c:v>
                </c:pt>
                <c:pt idx="35">
                  <c:v>8.7200000000000006</c:v>
                </c:pt>
                <c:pt idx="36">
                  <c:v>6.54</c:v>
                </c:pt>
                <c:pt idx="39">
                  <c:v>4.3600000000000003</c:v>
                </c:pt>
                <c:pt idx="40">
                  <c:v>8.7200000000000006</c:v>
                </c:pt>
                <c:pt idx="41">
                  <c:v>50.14</c:v>
                </c:pt>
                <c:pt idx="42">
                  <c:v>21.8</c:v>
                </c:pt>
                <c:pt idx="43">
                  <c:v>4.3600000000000003</c:v>
                </c:pt>
                <c:pt idx="44">
                  <c:v>6.5400000000000009</c:v>
                </c:pt>
                <c:pt idx="45">
                  <c:v>10.9</c:v>
                </c:pt>
                <c:pt idx="48">
                  <c:v>19.62</c:v>
                </c:pt>
                <c:pt idx="49">
                  <c:v>10.9</c:v>
                </c:pt>
                <c:pt idx="50">
                  <c:v>6.54000000000000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E0A-F24C-907B-BDE4005DCD86}"/>
            </c:ext>
          </c:extLst>
        </c:ser>
        <c:ser>
          <c:idx val="6"/>
          <c:order val="6"/>
          <c:tx>
            <c:strRef>
              <c:f>Sheet1!$H$1:$H$2</c:f>
              <c:strCache>
                <c:ptCount val="2"/>
                <c:pt idx="0">
                  <c:v>R95–1705 </c:v>
                </c:pt>
                <c:pt idx="1">
                  <c:v>Water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3:$A$53</c:f>
              <c:strCache>
                <c:ptCount val="51"/>
                <c:pt idx="0">
                  <c:v>Accession</c:v>
                </c:pt>
                <c:pt idx="2">
                  <c:v>P26413</c:v>
                </c:pt>
                <c:pt idx="3">
                  <c:v>P26413</c:v>
                </c:pt>
                <c:pt idx="4">
                  <c:v>Q39818</c:v>
                </c:pt>
                <c:pt idx="5">
                  <c:v>Q39818</c:v>
                </c:pt>
                <c:pt idx="6">
                  <c:v>P04795</c:v>
                </c:pt>
                <c:pt idx="7">
                  <c:v>P04795</c:v>
                </c:pt>
                <c:pt idx="8">
                  <c:v>B4X941</c:v>
                </c:pt>
                <c:pt idx="11">
                  <c:v>P08824</c:v>
                </c:pt>
                <c:pt idx="12">
                  <c:v>P02581</c:v>
                </c:pt>
                <c:pt idx="13">
                  <c:v>A0A762</c:v>
                </c:pt>
                <c:pt idx="16">
                  <c:v>B0M1A4</c:v>
                </c:pt>
                <c:pt idx="17">
                  <c:v>Q9ZT38</c:v>
                </c:pt>
                <c:pt idx="18">
                  <c:v>Q43758</c:v>
                </c:pt>
                <c:pt idx="19">
                  <c:v>C6SZ56</c:v>
                </c:pt>
                <c:pt idx="20">
                  <c:v>B3GV28</c:v>
                </c:pt>
                <c:pt idx="23">
                  <c:v>A8IKE5</c:v>
                </c:pt>
                <c:pt idx="24">
                  <c:v>O82560</c:v>
                </c:pt>
                <c:pt idx="25">
                  <c:v>C6ZJZ0</c:v>
                </c:pt>
                <c:pt idx="26">
                  <c:v>O23963</c:v>
                </c:pt>
                <c:pt idx="27">
                  <c:v>E5RPJ6</c:v>
                </c:pt>
                <c:pt idx="28">
                  <c:v>O81278</c:v>
                </c:pt>
                <c:pt idx="29">
                  <c:v>Q38IW8</c:v>
                </c:pt>
                <c:pt idx="30">
                  <c:v>Q93XE6</c:v>
                </c:pt>
                <c:pt idx="31">
                  <c:v>O22443</c:v>
                </c:pt>
                <c:pt idx="32">
                  <c:v>O22443</c:v>
                </c:pt>
                <c:pt idx="33">
                  <c:v>Q9XJ23</c:v>
                </c:pt>
                <c:pt idx="34">
                  <c:v>Q9SWA8</c:v>
                </c:pt>
                <c:pt idx="35">
                  <c:v>Q8GV24</c:v>
                </c:pt>
                <c:pt idx="36">
                  <c:v>O82560</c:v>
                </c:pt>
                <c:pt idx="39">
                  <c:v>D4N5G3</c:v>
                </c:pt>
                <c:pt idx="40">
                  <c:v>Q6RIB7</c:v>
                </c:pt>
                <c:pt idx="41">
                  <c:v>I1JJ05</c:v>
                </c:pt>
                <c:pt idx="42">
                  <c:v>Q2I0H4</c:v>
                </c:pt>
                <c:pt idx="43">
                  <c:v>Q39831</c:v>
                </c:pt>
                <c:pt idx="44">
                  <c:v>Q39832</c:v>
                </c:pt>
                <c:pt idx="45">
                  <c:v>Q6RUF6</c:v>
                </c:pt>
                <c:pt idx="48">
                  <c:v>Q6RIB7</c:v>
                </c:pt>
                <c:pt idx="49">
                  <c:v>P10743</c:v>
                </c:pt>
                <c:pt idx="50">
                  <c:v>Q9ZTZ2</c:v>
                </c:pt>
              </c:strCache>
            </c:strRef>
          </c:cat>
          <c:val>
            <c:numRef>
              <c:f>Sheet1!$H$3:$H$53</c:f>
              <c:numCache>
                <c:formatCode>General</c:formatCode>
                <c:ptCount val="51"/>
                <c:pt idx="0">
                  <c:v>0</c:v>
                </c:pt>
                <c:pt idx="2">
                  <c:v>10.9</c:v>
                </c:pt>
                <c:pt idx="3">
                  <c:v>2.1800000000000002</c:v>
                </c:pt>
                <c:pt idx="4">
                  <c:v>21.8</c:v>
                </c:pt>
                <c:pt idx="5">
                  <c:v>65.400000000000006</c:v>
                </c:pt>
                <c:pt idx="6">
                  <c:v>8.7200000000000006</c:v>
                </c:pt>
                <c:pt idx="7">
                  <c:v>0</c:v>
                </c:pt>
                <c:pt idx="8">
                  <c:v>21.8</c:v>
                </c:pt>
                <c:pt idx="11">
                  <c:v>2.1800000000000002</c:v>
                </c:pt>
                <c:pt idx="12">
                  <c:v>15.260000000000002</c:v>
                </c:pt>
                <c:pt idx="13">
                  <c:v>4.3600000000000003</c:v>
                </c:pt>
                <c:pt idx="16">
                  <c:v>4.3600000000000003</c:v>
                </c:pt>
                <c:pt idx="17">
                  <c:v>2.1800000000000002</c:v>
                </c:pt>
                <c:pt idx="18">
                  <c:v>2.1800000000000002</c:v>
                </c:pt>
                <c:pt idx="19">
                  <c:v>76.300000000000011</c:v>
                </c:pt>
                <c:pt idx="20">
                  <c:v>4.3600000000000003</c:v>
                </c:pt>
                <c:pt idx="23">
                  <c:v>4.3600000000000003</c:v>
                </c:pt>
                <c:pt idx="24">
                  <c:v>2.1800000000000002</c:v>
                </c:pt>
                <c:pt idx="25">
                  <c:v>2.1800000000000002</c:v>
                </c:pt>
                <c:pt idx="26">
                  <c:v>10.9</c:v>
                </c:pt>
                <c:pt idx="27">
                  <c:v>2.1800000000000002</c:v>
                </c:pt>
                <c:pt idx="28">
                  <c:v>2.1800000000000002</c:v>
                </c:pt>
                <c:pt idx="29">
                  <c:v>2.1800000000000002</c:v>
                </c:pt>
                <c:pt idx="30">
                  <c:v>2.1800000000000002</c:v>
                </c:pt>
                <c:pt idx="31">
                  <c:v>6.5400000000000009</c:v>
                </c:pt>
                <c:pt idx="32">
                  <c:v>2.1800000000000002</c:v>
                </c:pt>
                <c:pt idx="33">
                  <c:v>2.1800000000000002</c:v>
                </c:pt>
                <c:pt idx="34">
                  <c:v>8.7200000000000006</c:v>
                </c:pt>
                <c:pt idx="35">
                  <c:v>10.9</c:v>
                </c:pt>
                <c:pt idx="36">
                  <c:v>2.1800000000000002</c:v>
                </c:pt>
                <c:pt idx="39">
                  <c:v>6.5400000000000009</c:v>
                </c:pt>
                <c:pt idx="40">
                  <c:v>8.7200000000000006</c:v>
                </c:pt>
                <c:pt idx="41">
                  <c:v>21.8</c:v>
                </c:pt>
                <c:pt idx="42">
                  <c:v>21.8</c:v>
                </c:pt>
                <c:pt idx="43">
                  <c:v>8.7200000000000006</c:v>
                </c:pt>
                <c:pt idx="44">
                  <c:v>6.5400000000000009</c:v>
                </c:pt>
                <c:pt idx="45">
                  <c:v>10.9</c:v>
                </c:pt>
                <c:pt idx="48">
                  <c:v>10.9</c:v>
                </c:pt>
                <c:pt idx="49">
                  <c:v>8.7200000000000006</c:v>
                </c:pt>
                <c:pt idx="50">
                  <c:v>2.18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E0A-F24C-907B-BDE4005DCD86}"/>
            </c:ext>
          </c:extLst>
        </c:ser>
        <c:ser>
          <c:idx val="7"/>
          <c:order val="7"/>
          <c:tx>
            <c:strRef>
              <c:f>Sheet1!$I$1:$I$2</c:f>
              <c:strCache>
                <c:ptCount val="2"/>
                <c:pt idx="0">
                  <c:v>R95–1705 </c:v>
                </c:pt>
                <c:pt idx="1">
                  <c:v>Heat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3:$A$53</c:f>
              <c:strCache>
                <c:ptCount val="51"/>
                <c:pt idx="0">
                  <c:v>Accession</c:v>
                </c:pt>
                <c:pt idx="2">
                  <c:v>P26413</c:v>
                </c:pt>
                <c:pt idx="3">
                  <c:v>P26413</c:v>
                </c:pt>
                <c:pt idx="4">
                  <c:v>Q39818</c:v>
                </c:pt>
                <c:pt idx="5">
                  <c:v>Q39818</c:v>
                </c:pt>
                <c:pt idx="6">
                  <c:v>P04795</c:v>
                </c:pt>
                <c:pt idx="7">
                  <c:v>P04795</c:v>
                </c:pt>
                <c:pt idx="8">
                  <c:v>B4X941</c:v>
                </c:pt>
                <c:pt idx="11">
                  <c:v>P08824</c:v>
                </c:pt>
                <c:pt idx="12">
                  <c:v>P02581</c:v>
                </c:pt>
                <c:pt idx="13">
                  <c:v>A0A762</c:v>
                </c:pt>
                <c:pt idx="16">
                  <c:v>B0M1A4</c:v>
                </c:pt>
                <c:pt idx="17">
                  <c:v>Q9ZT38</c:v>
                </c:pt>
                <c:pt idx="18">
                  <c:v>Q43758</c:v>
                </c:pt>
                <c:pt idx="19">
                  <c:v>C6SZ56</c:v>
                </c:pt>
                <c:pt idx="20">
                  <c:v>B3GV28</c:v>
                </c:pt>
                <c:pt idx="23">
                  <c:v>A8IKE5</c:v>
                </c:pt>
                <c:pt idx="24">
                  <c:v>O82560</c:v>
                </c:pt>
                <c:pt idx="25">
                  <c:v>C6ZJZ0</c:v>
                </c:pt>
                <c:pt idx="26">
                  <c:v>O23963</c:v>
                </c:pt>
                <c:pt idx="27">
                  <c:v>E5RPJ6</c:v>
                </c:pt>
                <c:pt idx="28">
                  <c:v>O81278</c:v>
                </c:pt>
                <c:pt idx="29">
                  <c:v>Q38IW8</c:v>
                </c:pt>
                <c:pt idx="30">
                  <c:v>Q93XE6</c:v>
                </c:pt>
                <c:pt idx="31">
                  <c:v>O22443</c:v>
                </c:pt>
                <c:pt idx="32">
                  <c:v>O22443</c:v>
                </c:pt>
                <c:pt idx="33">
                  <c:v>Q9XJ23</c:v>
                </c:pt>
                <c:pt idx="34">
                  <c:v>Q9SWA8</c:v>
                </c:pt>
                <c:pt idx="35">
                  <c:v>Q8GV24</c:v>
                </c:pt>
                <c:pt idx="36">
                  <c:v>O82560</c:v>
                </c:pt>
                <c:pt idx="39">
                  <c:v>D4N5G3</c:v>
                </c:pt>
                <c:pt idx="40">
                  <c:v>Q6RIB7</c:v>
                </c:pt>
                <c:pt idx="41">
                  <c:v>I1JJ05</c:v>
                </c:pt>
                <c:pt idx="42">
                  <c:v>Q2I0H4</c:v>
                </c:pt>
                <c:pt idx="43">
                  <c:v>Q39831</c:v>
                </c:pt>
                <c:pt idx="44">
                  <c:v>Q39832</c:v>
                </c:pt>
                <c:pt idx="45">
                  <c:v>Q6RUF6</c:v>
                </c:pt>
                <c:pt idx="48">
                  <c:v>Q6RIB7</c:v>
                </c:pt>
                <c:pt idx="49">
                  <c:v>P10743</c:v>
                </c:pt>
                <c:pt idx="50">
                  <c:v>Q9ZTZ2</c:v>
                </c:pt>
              </c:strCache>
            </c:strRef>
          </c:cat>
          <c:val>
            <c:numRef>
              <c:f>Sheet1!$I$3:$I$53</c:f>
              <c:numCache>
                <c:formatCode>General</c:formatCode>
                <c:ptCount val="51"/>
                <c:pt idx="0">
                  <c:v>0</c:v>
                </c:pt>
                <c:pt idx="2">
                  <c:v>8.7200000000000006</c:v>
                </c:pt>
                <c:pt idx="3">
                  <c:v>2.1800000000000002</c:v>
                </c:pt>
                <c:pt idx="4">
                  <c:v>10.9</c:v>
                </c:pt>
                <c:pt idx="5">
                  <c:v>21.8</c:v>
                </c:pt>
                <c:pt idx="6">
                  <c:v>2.1800000000000002</c:v>
                </c:pt>
                <c:pt idx="7">
                  <c:v>2.1800000000000002</c:v>
                </c:pt>
                <c:pt idx="8">
                  <c:v>19.62</c:v>
                </c:pt>
                <c:pt idx="11">
                  <c:v>0</c:v>
                </c:pt>
                <c:pt idx="12">
                  <c:v>13.080000000000002</c:v>
                </c:pt>
                <c:pt idx="13">
                  <c:v>2.1800000000000002</c:v>
                </c:pt>
                <c:pt idx="16">
                  <c:v>6.5400000000000009</c:v>
                </c:pt>
                <c:pt idx="17">
                  <c:v>2.1800000000000002</c:v>
                </c:pt>
                <c:pt idx="18">
                  <c:v>4.3600000000000003</c:v>
                </c:pt>
                <c:pt idx="19">
                  <c:v>65.400000000000006</c:v>
                </c:pt>
                <c:pt idx="20">
                  <c:v>2.1800000000000002</c:v>
                </c:pt>
                <c:pt idx="23">
                  <c:v>4.3600000000000003</c:v>
                </c:pt>
                <c:pt idx="24">
                  <c:v>4.3600000000000003</c:v>
                </c:pt>
                <c:pt idx="25">
                  <c:v>2.1800000000000002</c:v>
                </c:pt>
                <c:pt idx="26">
                  <c:v>2.1800000000000002</c:v>
                </c:pt>
                <c:pt idx="27">
                  <c:v>4.3600000000000003</c:v>
                </c:pt>
                <c:pt idx="28">
                  <c:v>0</c:v>
                </c:pt>
                <c:pt idx="29">
                  <c:v>2.1800000000000002</c:v>
                </c:pt>
                <c:pt idx="30">
                  <c:v>2.1800000000000002</c:v>
                </c:pt>
                <c:pt idx="31">
                  <c:v>2.1800000000000002</c:v>
                </c:pt>
                <c:pt idx="32">
                  <c:v>2.1800000000000002</c:v>
                </c:pt>
                <c:pt idx="33">
                  <c:v>2.1800000000000002</c:v>
                </c:pt>
                <c:pt idx="34">
                  <c:v>8.7200000000000006</c:v>
                </c:pt>
                <c:pt idx="35">
                  <c:v>2.1800000000000002</c:v>
                </c:pt>
                <c:pt idx="36">
                  <c:v>2.1800000000000002</c:v>
                </c:pt>
                <c:pt idx="39">
                  <c:v>4.3600000000000003</c:v>
                </c:pt>
                <c:pt idx="40">
                  <c:v>10.9</c:v>
                </c:pt>
                <c:pt idx="41">
                  <c:v>21.8</c:v>
                </c:pt>
                <c:pt idx="42">
                  <c:v>10.9</c:v>
                </c:pt>
                <c:pt idx="43">
                  <c:v>4.3600000000000003</c:v>
                </c:pt>
                <c:pt idx="44">
                  <c:v>4.3600000000000003</c:v>
                </c:pt>
                <c:pt idx="45">
                  <c:v>2.1800000000000002</c:v>
                </c:pt>
                <c:pt idx="48">
                  <c:v>10.9</c:v>
                </c:pt>
                <c:pt idx="49">
                  <c:v>8.7200000000000006</c:v>
                </c:pt>
                <c:pt idx="50">
                  <c:v>2.18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0E0A-F24C-907B-BDE4005DCD86}"/>
            </c:ext>
          </c:extLst>
        </c:ser>
        <c:ser>
          <c:idx val="8"/>
          <c:order val="8"/>
          <c:tx>
            <c:strRef>
              <c:f>Sheet1!$J$1:$J$2</c:f>
              <c:strCache>
                <c:ptCount val="2"/>
                <c:pt idx="0">
                  <c:v>R95–1705 </c:v>
                </c:pt>
                <c:pt idx="1">
                  <c:v>Both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3:$A$53</c:f>
              <c:strCache>
                <c:ptCount val="51"/>
                <c:pt idx="0">
                  <c:v>Accession</c:v>
                </c:pt>
                <c:pt idx="2">
                  <c:v>P26413</c:v>
                </c:pt>
                <c:pt idx="3">
                  <c:v>P26413</c:v>
                </c:pt>
                <c:pt idx="4">
                  <c:v>Q39818</c:v>
                </c:pt>
                <c:pt idx="5">
                  <c:v>Q39818</c:v>
                </c:pt>
                <c:pt idx="6">
                  <c:v>P04795</c:v>
                </c:pt>
                <c:pt idx="7">
                  <c:v>P04795</c:v>
                </c:pt>
                <c:pt idx="8">
                  <c:v>B4X941</c:v>
                </c:pt>
                <c:pt idx="11">
                  <c:v>P08824</c:v>
                </c:pt>
                <c:pt idx="12">
                  <c:v>P02581</c:v>
                </c:pt>
                <c:pt idx="13">
                  <c:v>A0A762</c:v>
                </c:pt>
                <c:pt idx="16">
                  <c:v>B0M1A4</c:v>
                </c:pt>
                <c:pt idx="17">
                  <c:v>Q9ZT38</c:v>
                </c:pt>
                <c:pt idx="18">
                  <c:v>Q43758</c:v>
                </c:pt>
                <c:pt idx="19">
                  <c:v>C6SZ56</c:v>
                </c:pt>
                <c:pt idx="20">
                  <c:v>B3GV28</c:v>
                </c:pt>
                <c:pt idx="23">
                  <c:v>A8IKE5</c:v>
                </c:pt>
                <c:pt idx="24">
                  <c:v>O82560</c:v>
                </c:pt>
                <c:pt idx="25">
                  <c:v>C6ZJZ0</c:v>
                </c:pt>
                <c:pt idx="26">
                  <c:v>O23963</c:v>
                </c:pt>
                <c:pt idx="27">
                  <c:v>E5RPJ6</c:v>
                </c:pt>
                <c:pt idx="28">
                  <c:v>O81278</c:v>
                </c:pt>
                <c:pt idx="29">
                  <c:v>Q38IW8</c:v>
                </c:pt>
                <c:pt idx="30">
                  <c:v>Q93XE6</c:v>
                </c:pt>
                <c:pt idx="31">
                  <c:v>O22443</c:v>
                </c:pt>
                <c:pt idx="32">
                  <c:v>O22443</c:v>
                </c:pt>
                <c:pt idx="33">
                  <c:v>Q9XJ23</c:v>
                </c:pt>
                <c:pt idx="34">
                  <c:v>Q9SWA8</c:v>
                </c:pt>
                <c:pt idx="35">
                  <c:v>Q8GV24</c:v>
                </c:pt>
                <c:pt idx="36">
                  <c:v>O82560</c:v>
                </c:pt>
                <c:pt idx="39">
                  <c:v>D4N5G3</c:v>
                </c:pt>
                <c:pt idx="40">
                  <c:v>Q6RIB7</c:v>
                </c:pt>
                <c:pt idx="41">
                  <c:v>I1JJ05</c:v>
                </c:pt>
                <c:pt idx="42">
                  <c:v>Q2I0H4</c:v>
                </c:pt>
                <c:pt idx="43">
                  <c:v>Q39831</c:v>
                </c:pt>
                <c:pt idx="44">
                  <c:v>Q39832</c:v>
                </c:pt>
                <c:pt idx="45">
                  <c:v>Q6RUF6</c:v>
                </c:pt>
                <c:pt idx="48">
                  <c:v>Q6RIB7</c:v>
                </c:pt>
                <c:pt idx="49">
                  <c:v>P10743</c:v>
                </c:pt>
                <c:pt idx="50">
                  <c:v>Q9ZTZ2</c:v>
                </c:pt>
              </c:strCache>
            </c:strRef>
          </c:cat>
          <c:val>
            <c:numRef>
              <c:f>Sheet1!$J$3:$J$53</c:f>
              <c:numCache>
                <c:formatCode>General</c:formatCode>
                <c:ptCount val="51"/>
                <c:pt idx="0">
                  <c:v>0</c:v>
                </c:pt>
                <c:pt idx="2">
                  <c:v>10.9</c:v>
                </c:pt>
                <c:pt idx="3">
                  <c:v>8.7200000000000006</c:v>
                </c:pt>
                <c:pt idx="4">
                  <c:v>10.9</c:v>
                </c:pt>
                <c:pt idx="5">
                  <c:v>65.400000000000006</c:v>
                </c:pt>
                <c:pt idx="6">
                  <c:v>10.9</c:v>
                </c:pt>
                <c:pt idx="7">
                  <c:v>2.1800000000000002</c:v>
                </c:pt>
                <c:pt idx="8">
                  <c:v>10.9</c:v>
                </c:pt>
                <c:pt idx="11">
                  <c:v>0</c:v>
                </c:pt>
                <c:pt idx="12">
                  <c:v>10.9</c:v>
                </c:pt>
                <c:pt idx="13">
                  <c:v>4.3600000000000003</c:v>
                </c:pt>
                <c:pt idx="16">
                  <c:v>21.8</c:v>
                </c:pt>
                <c:pt idx="17">
                  <c:v>4.3600000000000003</c:v>
                </c:pt>
                <c:pt idx="18">
                  <c:v>2.1800000000000002</c:v>
                </c:pt>
                <c:pt idx="19">
                  <c:v>54.500000000000007</c:v>
                </c:pt>
                <c:pt idx="20">
                  <c:v>4.3600000000000003</c:v>
                </c:pt>
                <c:pt idx="23">
                  <c:v>2.1800000000000002</c:v>
                </c:pt>
                <c:pt idx="24">
                  <c:v>4.3600000000000003</c:v>
                </c:pt>
                <c:pt idx="25">
                  <c:v>2.1800000000000002</c:v>
                </c:pt>
                <c:pt idx="26">
                  <c:v>4.3600000000000003</c:v>
                </c:pt>
                <c:pt idx="27">
                  <c:v>6.5400000000000009</c:v>
                </c:pt>
                <c:pt idx="28">
                  <c:v>2.1800000000000002</c:v>
                </c:pt>
                <c:pt idx="29">
                  <c:v>2.1800000000000002</c:v>
                </c:pt>
                <c:pt idx="30">
                  <c:v>2.1800000000000002</c:v>
                </c:pt>
                <c:pt idx="31">
                  <c:v>17.440000000000001</c:v>
                </c:pt>
                <c:pt idx="32">
                  <c:v>6.5400000000000009</c:v>
                </c:pt>
                <c:pt idx="33">
                  <c:v>6.5400000000000009</c:v>
                </c:pt>
                <c:pt idx="34">
                  <c:v>8.7200000000000006</c:v>
                </c:pt>
                <c:pt idx="35">
                  <c:v>6.5400000000000009</c:v>
                </c:pt>
                <c:pt idx="36">
                  <c:v>4.3600000000000003</c:v>
                </c:pt>
                <c:pt idx="39">
                  <c:v>10.9</c:v>
                </c:pt>
                <c:pt idx="40">
                  <c:v>17.440000000000001</c:v>
                </c:pt>
                <c:pt idx="41">
                  <c:v>21.8</c:v>
                </c:pt>
                <c:pt idx="42">
                  <c:v>21.8</c:v>
                </c:pt>
                <c:pt idx="43">
                  <c:v>4.3600000000000003</c:v>
                </c:pt>
                <c:pt idx="44">
                  <c:v>6.5400000000000009</c:v>
                </c:pt>
                <c:pt idx="45">
                  <c:v>4.3600000000000003</c:v>
                </c:pt>
                <c:pt idx="48">
                  <c:v>19.62</c:v>
                </c:pt>
                <c:pt idx="49">
                  <c:v>8.7200000000000006</c:v>
                </c:pt>
                <c:pt idx="50">
                  <c:v>2.18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E0A-F24C-907B-BDE4005DCD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33839200"/>
        <c:axId val="1996301664"/>
      </c:barChart>
      <c:catAx>
        <c:axId val="19338392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96301664"/>
        <c:crosses val="autoZero"/>
        <c:auto val="1"/>
        <c:lblAlgn val="ctr"/>
        <c:lblOffset val="100"/>
        <c:noMultiLvlLbl val="0"/>
      </c:catAx>
      <c:valAx>
        <c:axId val="19963016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8392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7.5512645311180265E-2"/>
          <c:y val="0.90185954159013226"/>
          <c:w val="0.84024121067106139"/>
          <c:h val="6.862171160385810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F05C11-2CDD-1240-95DB-366FC2AAD3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B2F8B4-5902-A944-B91B-0EF3917EE8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129847-FC80-834D-A303-379EA2992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0A3EB-3776-B94E-BF8F-1D637B5F2D71}" type="datetimeFigureOut">
              <a:rPr lang="en-US" smtClean="0"/>
              <a:t>1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85B129-BF7C-F249-9E4C-09C3D4560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040E3B-69B3-C54E-8437-76DBBF370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498C1-7E3F-7D4A-A31E-5C721F1456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973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317D56-C1ED-F744-BE98-6992750D59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155384-9BCE-0443-B968-5A5ADA6454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A8282C-0D81-BA41-90D6-38CCEF5AB2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0A3EB-3776-B94E-BF8F-1D637B5F2D71}" type="datetimeFigureOut">
              <a:rPr lang="en-US" smtClean="0"/>
              <a:t>1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461D8E-A5BC-874A-9B3A-19A9F1C3F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8B28F5-A0F9-5B40-81E3-205F67C6E2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498C1-7E3F-7D4A-A31E-5C721F1456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584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FCC3EEC-DB7D-3146-829E-AC9D97486E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528879-8248-6741-9F77-0E3CA45E1D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72DDDB-6CE0-2444-AD5D-AE7F22E862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0A3EB-3776-B94E-BF8F-1D637B5F2D71}" type="datetimeFigureOut">
              <a:rPr lang="en-US" smtClean="0"/>
              <a:t>1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969958-BDAC-214A-93A9-230E507963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63CC8C-932F-D147-818B-B27A45C60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498C1-7E3F-7D4A-A31E-5C721F1456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866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E665EE-A46B-B046-BD87-B6AF3C5CA5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F93BBD-CC6A-ED40-9165-FD27C82E3B2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B7FA54-F3ED-AF42-A81C-0A2D27F86F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0A3EB-3776-B94E-BF8F-1D637B5F2D71}" type="datetimeFigureOut">
              <a:rPr lang="en-US" smtClean="0"/>
              <a:t>1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F3BC3F-F261-0D4D-BF3E-E8F24E22AE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0F4B32-7310-1140-AEE9-01C1449D3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498C1-7E3F-7D4A-A31E-5C721F1456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056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BF4056-0DC3-A24A-ACD9-69F032333A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CD3B5C-12E7-C446-AAD1-7340AA4E7A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D97AE2-6A4D-4141-B2F5-EE2FCF0133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0A3EB-3776-B94E-BF8F-1D637B5F2D71}" type="datetimeFigureOut">
              <a:rPr lang="en-US" smtClean="0"/>
              <a:t>1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4CF4C0-5BE9-E44F-AA96-4229203FF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6BF094-2395-E44D-BD4D-4E30BACCE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498C1-7E3F-7D4A-A31E-5C721F1456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228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9C0823-30E1-5A41-AB94-227EC2EF76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05D6A3-A7D1-3447-81DE-162FA2520B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61E612-F3C1-5C40-970A-F22D350572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00921D-4214-ED45-B24C-38954EFEC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0A3EB-3776-B94E-BF8F-1D637B5F2D71}" type="datetimeFigureOut">
              <a:rPr lang="en-US" smtClean="0"/>
              <a:t>1/8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C35C93-8E2B-2D45-9171-229FFEA56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2D058F-5061-8340-9D64-44D5CF1F9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498C1-7E3F-7D4A-A31E-5C721F1456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100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325876-5A0B-6045-8BDB-6971F6C342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CA9BD1-AEFB-6C4E-BADB-2EF263A7A9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178E2F-511B-204C-A35E-49A20B21D1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71D2DD3-DB83-F342-A3DB-24E0137B76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6977978-2CAD-644B-89BA-7918599FDC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7714A52-5A70-7342-B398-764785F02C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0A3EB-3776-B94E-BF8F-1D637B5F2D71}" type="datetimeFigureOut">
              <a:rPr lang="en-US" smtClean="0"/>
              <a:t>1/8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3CCFE48-A855-7040-B61C-D3DFB82F06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5885192-80BA-3E46-A1F5-292DB9CFDD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498C1-7E3F-7D4A-A31E-5C721F1456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1650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05311C-6355-BB4D-A169-6D746A25F3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D89BB8A-29F4-2A48-B7A3-07FE4727D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0A3EB-3776-B94E-BF8F-1D637B5F2D71}" type="datetimeFigureOut">
              <a:rPr lang="en-US" smtClean="0"/>
              <a:t>1/8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2D582C6-E25E-8349-9B8A-EF26BBCCDA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A335DF4-D328-3044-98FD-802E3A79CF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498C1-7E3F-7D4A-A31E-5C721F1456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113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E564FE5-A461-414D-A01D-E992AA864D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0A3EB-3776-B94E-BF8F-1D637B5F2D71}" type="datetimeFigureOut">
              <a:rPr lang="en-US" smtClean="0"/>
              <a:t>1/8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1524BD6-80EE-304E-A73B-1345C59C8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8E54D58-A044-9F4A-AAF8-EF3AC29370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498C1-7E3F-7D4A-A31E-5C721F1456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791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634A10-F0FE-A243-84C0-7CB26E7601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172EBE-9E47-BD4C-8CA9-8809A8A529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AE21BD-4DBC-F747-A253-0D32494C55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EED8A9-1BAE-DE44-AD0F-22F08F89A5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0A3EB-3776-B94E-BF8F-1D637B5F2D71}" type="datetimeFigureOut">
              <a:rPr lang="en-US" smtClean="0"/>
              <a:t>1/8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3CBF2E-FD76-1E46-A0BF-1C8DE6862D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305B6B-B593-BC49-AE30-97AA13BF09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498C1-7E3F-7D4A-A31E-5C721F1456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165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B07E46-2E2E-8D4F-BF8B-191C532E94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C42BA6F-BD30-834B-9CA7-BC136D3E0F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C475BD-48AF-734D-9DD1-78E4A520FA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523E0B-4A59-7A49-AF7A-6C055950CB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0A3EB-3776-B94E-BF8F-1D637B5F2D71}" type="datetimeFigureOut">
              <a:rPr lang="en-US" smtClean="0"/>
              <a:t>1/8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5F3570-F028-594E-AE65-61E7DFD5F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249799-7508-904D-B962-A8954EB57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498C1-7E3F-7D4A-A31E-5C721F1456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3541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A510C2E-BD46-4D47-AE7E-CF26003D8C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1C92BC-703A-8C49-B8F4-ECF56723C8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CB78DF-7E89-2E40-8067-37089EECCD8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D0A3EB-3776-B94E-BF8F-1D637B5F2D71}" type="datetimeFigureOut">
              <a:rPr lang="en-US" smtClean="0"/>
              <a:t>1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AB1DED-B23B-2848-8391-9AE4B96920C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834A84-5520-A747-B6F8-84FF264011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4498C1-7E3F-7D4A-A31E-5C721F1456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120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EC2FD08F-8517-5344-97E9-388A88447E6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7373105"/>
              </p:ext>
            </p:extLst>
          </p:nvPr>
        </p:nvGraphicFramePr>
        <p:xfrm>
          <a:off x="434340" y="248357"/>
          <a:ext cx="11633482" cy="64535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4580A471-9870-6F45-B7CB-D6E625908FC3}"/>
              </a:ext>
            </a:extLst>
          </p:cNvPr>
          <p:cNvSpPr txBox="1"/>
          <p:nvPr/>
        </p:nvSpPr>
        <p:spPr>
          <a:xfrm>
            <a:off x="4655325" y="5781459"/>
            <a:ext cx="28813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ipro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D of the stress responsive protein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E418B0F-80CE-A54C-AAE2-7FC435E420F3}"/>
              </a:ext>
            </a:extLst>
          </p:cNvPr>
          <p:cNvSpPr txBox="1"/>
          <p:nvPr/>
        </p:nvSpPr>
        <p:spPr>
          <a:xfrm rot="16200000">
            <a:off x="-1030895" y="3409459"/>
            <a:ext cx="25685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Protein density in Gel Image</a:t>
            </a:r>
          </a:p>
        </p:txBody>
      </p:sp>
    </p:spTree>
    <p:extLst>
      <p:ext uri="{BB962C8B-B14F-4D97-AF65-F5344CB8AC3E}">
        <p14:creationId xmlns:p14="http://schemas.microsoft.com/office/powerpoint/2010/main" val="12064206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13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am, Ramesh</dc:creator>
  <cp:lastModifiedBy>Katam, Ramesh</cp:lastModifiedBy>
  <cp:revision>8</cp:revision>
  <dcterms:created xsi:type="dcterms:W3CDTF">2019-10-18T15:19:21Z</dcterms:created>
  <dcterms:modified xsi:type="dcterms:W3CDTF">2020-01-08T20:26:56Z</dcterms:modified>
</cp:coreProperties>
</file>